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2" r:id="rId2"/>
    <p:sldId id="313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1" autoAdjust="0"/>
    <p:restoredTop sz="94660"/>
  </p:normalViewPr>
  <p:slideViewPr>
    <p:cSldViewPr snapToGrid="0">
      <p:cViewPr varScale="1">
        <p:scale>
          <a:sx n="88" d="100"/>
          <a:sy n="88" d="100"/>
        </p:scale>
        <p:origin x="255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D5D5CF0-52D1-4D31-6E69-479457B506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6759C10-4C45-F7DD-FA1A-E1F33CCE87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5FF02AD-AFF6-F329-3829-EA66C6CAB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E4634C6-0008-9C21-2538-8A00D82E6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B23C7D1-1208-2073-E12F-E66CCB763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8350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8957FF-D9FA-38ED-46E2-FB1D23FAC1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A039C47-2212-E024-FAB3-7653D3DF99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E292C38-2454-4EC1-A831-860B33E9B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335E4A3-0D3D-2FD6-0369-4018F1BE5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2E219A0-46A6-52AF-A082-C00E42ACA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0671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BD0D55B-1D78-ACFC-96D0-8879154A5C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E8DE0B4-2076-2643-26C6-447FF8FEF7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3754935-015B-461D-F363-85002C3C9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90EA9A0-8456-CFB7-66CB-F822A6DE2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8A9957-4356-E019-CAEC-C4A0DFCFE7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756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FCD5E4-6FDF-C5FD-B7BE-0823D59A23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80B7A28-776F-44D7-454C-F28AD7273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284028E-00FE-019E-5EB6-F74FCC817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140C27F-A65A-3A01-3ED5-5B8A37C2A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A462C0E-2BF9-10BF-A96E-DC77CCF2A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6774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84BAA6-E5D5-7048-FD03-66FB04B042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7BC28F2-C6A9-6E35-B220-AFBFAA4F8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9E3FE01-40CF-9522-D59E-4E7C5A5E9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A06AEFB-5045-E44C-6C4B-C37458214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126D2F8-DB65-5CFD-4DFA-A0B5E373F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4916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3E6EF9-5752-9AE9-F102-0B8C14BEA6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08E528A-72A7-D236-85D7-04B539B88A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642C529-DC10-226C-FFD4-D0E80E926A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228429E-A56C-AFCA-032C-0059DC0CE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5F18B02-E9F3-4D9D-C5DD-2195C0630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CE95061-B8B2-77A4-4F0A-6427309A9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4677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A70EE6-5AF1-A496-B423-2F28415BD8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5C7DEB0-5D32-D504-4FE6-7EC2092668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5B7CE66-4022-0F55-9377-45BC48C3D9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6838B8C-F851-BD6B-8207-8945239BF3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D7E0FD6-6CF5-F776-2A93-55089A107A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EB26233-9835-6CAC-B80A-6C08676BB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8DC030D-AC7D-5A46-8BD8-E4B761BCE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406C8D2-FCC9-E8D5-0BCA-A43DB7680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777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8884CE-29CE-6C34-E0D9-44E7B7659D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BCACD08-DCC1-7CAC-3018-BC23FAFB5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A92E9DF-3126-CC01-BE9E-749104918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E2B39B5-25F0-7DEA-9176-2F609E6AF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2155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311B3D8-06D7-D1B1-C0EB-D01F28A8B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98C1CAB-57E1-2C8D-5278-472CF532E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75272FA-8597-C146-E159-4923290BD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0918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AA8B7C5-A900-5934-6D88-9D25EBE3B0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AA6371B-1573-C7CA-8B86-F5261185E4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4FD1E67-6638-C7ED-B219-A411AABFA5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0E17D4A-08AB-00C5-E786-5A7E764DC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6324297-9353-3432-2FE0-8BAEB8C2E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EAD825E-1136-4E2A-3236-D38A6107E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5767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484D50-8498-233B-ABC9-71D7482C9C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A9A002D-DACF-EEFB-4508-834F50AD86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A16416F-BD40-F165-7DA1-F8D01C628F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A3D4BE9-DE62-F83D-5270-1E06DEF94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8ECD1F5-D9E5-F647-3402-D109A3EEF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3D5615A-4E93-CD86-A8A8-12B661164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5699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6D974B0-CA47-579D-B31B-7DCC8FEB7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95D999B-AC25-7DF9-22FF-58AACE7063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C3311BB-7E6D-FE86-5CCC-F182359415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9C321-353D-48F7-8AA4-8E5112BC69F8}" type="datetimeFigureOut">
              <a:rPr lang="es-ES" smtClean="0"/>
              <a:t>18/03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EFADCE8-8808-F6C2-4EB5-C78DDDEC52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9FC906E-4A9D-0404-45D3-96E26146E3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6D923-EE16-48B7-AC09-1824B55D79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9590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uadroTexto 19">
            <a:extLst>
              <a:ext uri="{FF2B5EF4-FFF2-40B4-BE49-F238E27FC236}">
                <a16:creationId xmlns:a16="http://schemas.microsoft.com/office/drawing/2014/main" id="{6846196A-0C65-C947-702E-FCF956859DCF}"/>
              </a:ext>
            </a:extLst>
          </p:cNvPr>
          <p:cNvSpPr txBox="1"/>
          <p:nvPr/>
        </p:nvSpPr>
        <p:spPr>
          <a:xfrm>
            <a:off x="-70431" y="-30515"/>
            <a:ext cx="1135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26" name="Grupo 25">
            <a:extLst>
              <a:ext uri="{FF2B5EF4-FFF2-40B4-BE49-F238E27FC236}">
                <a16:creationId xmlns:a16="http://schemas.microsoft.com/office/drawing/2014/main" id="{A5AF83A7-64E0-A91F-640B-9B80E73A9880}"/>
              </a:ext>
            </a:extLst>
          </p:cNvPr>
          <p:cNvGrpSpPr>
            <a:grpSpLocks noGrp="1" noUngrp="1" noRot="1" noMove="1" noResize="1"/>
          </p:cNvGrpSpPr>
          <p:nvPr/>
        </p:nvGrpSpPr>
        <p:grpSpPr>
          <a:xfrm>
            <a:off x="320549" y="314697"/>
            <a:ext cx="11370844" cy="5742020"/>
            <a:chOff x="320549" y="314697"/>
            <a:chExt cx="11370844" cy="5742020"/>
          </a:xfrm>
        </p:grpSpPr>
        <p:sp>
          <p:nvSpPr>
            <p:cNvPr id="113" name="58 Rectángulo">
              <a:extLst>
                <a:ext uri="{FF2B5EF4-FFF2-40B4-BE49-F238E27FC236}">
                  <a16:creationId xmlns:a16="http://schemas.microsoft.com/office/drawing/2014/main" id="{BA9AD465-62D2-879A-42AD-5418018601A5}"/>
                </a:ext>
              </a:extLst>
            </p:cNvPr>
            <p:cNvSpPr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2792966" y="2286876"/>
              <a:ext cx="263030" cy="1509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14" name="58 Rectángulo">
              <a:extLst>
                <a:ext uri="{FF2B5EF4-FFF2-40B4-BE49-F238E27FC236}">
                  <a16:creationId xmlns:a16="http://schemas.microsoft.com/office/drawing/2014/main" id="{F8596056-01E1-5CA3-9C14-DF8CBF91C963}"/>
                </a:ext>
              </a:extLst>
            </p:cNvPr>
            <p:cNvSpPr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2857628" y="1604151"/>
              <a:ext cx="139923" cy="3044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8" name="CuadroTexto 257">
              <a:extLst>
                <a:ext uri="{FF2B5EF4-FFF2-40B4-BE49-F238E27FC236}">
                  <a16:creationId xmlns:a16="http://schemas.microsoft.com/office/drawing/2014/main" id="{FB5F80E7-A2D4-9BF3-AB76-AF00A476BD03}"/>
                </a:ext>
              </a:extLst>
            </p:cNvPr>
            <p:cNvSpPr txBox="1"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320549" y="647668"/>
              <a:ext cx="1135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grpSp>
          <p:nvGrpSpPr>
            <p:cNvPr id="7" name="Grupo 6">
              <a:extLst>
                <a:ext uri="{FF2B5EF4-FFF2-40B4-BE49-F238E27FC236}">
                  <a16:creationId xmlns:a16="http://schemas.microsoft.com/office/drawing/2014/main" id="{0C3CC5BC-C1E8-DD2C-1D9B-75090A656543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4788274" y="1111693"/>
              <a:ext cx="1987288" cy="1403576"/>
              <a:chOff x="348051" y="3284633"/>
              <a:chExt cx="1987288" cy="1403576"/>
            </a:xfrm>
          </p:grpSpPr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id="{CE39988B-BD13-066D-1FE3-F8CC63F8099E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 noCrop="1"/>
              </p:cNvPicPr>
              <p:nvPr/>
            </p:nvPicPr>
            <p:blipFill rotWithShape="1">
              <a:blip r:embed="rId2"/>
              <a:srcRect l="8184" t="11551" b="9685"/>
              <a:stretch/>
            </p:blipFill>
            <p:spPr>
              <a:xfrm>
                <a:off x="527190" y="3284634"/>
                <a:ext cx="1808149" cy="1258690"/>
              </a:xfrm>
              <a:prstGeom prst="rect">
                <a:avLst/>
              </a:prstGeom>
            </p:spPr>
          </p:pic>
          <p:sp>
            <p:nvSpPr>
              <p:cNvPr id="116" name="58 Rectángulo">
                <a:extLst>
                  <a:ext uri="{FF2B5EF4-FFF2-40B4-BE49-F238E27FC236}">
                    <a16:creationId xmlns:a16="http://schemas.microsoft.com/office/drawing/2014/main" id="{F6CE40AA-2B73-4044-46E3-61E89067BFB4}"/>
                  </a:ext>
                </a:extLst>
              </p:cNvPr>
              <p:cNvSpPr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348051" y="4417443"/>
                <a:ext cx="263030" cy="15095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22" name="58 Rectángulo">
                <a:extLst>
                  <a:ext uri="{FF2B5EF4-FFF2-40B4-BE49-F238E27FC236}">
                    <a16:creationId xmlns:a16="http://schemas.microsoft.com/office/drawing/2014/main" id="{4A5E2562-AB8E-9C60-631F-2A3668A75499}"/>
                  </a:ext>
                </a:extLst>
              </p:cNvPr>
              <p:cNvSpPr>
                <a:spLocks noGrp="1" noRot="1" noMove="1" noResize="1" noEditPoints="1" noAdjustHandles="1" noChangeArrowheads="1" noChangeShapeType="1"/>
              </p:cNvSpPr>
              <p:nvPr/>
            </p:nvSpPr>
            <p:spPr>
              <a:xfrm rot="5400000">
                <a:off x="782865" y="3752965"/>
                <a:ext cx="723724" cy="15095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26" name="90 CuadroTexto">
                <a:extLst>
                  <a:ext uri="{FF2B5EF4-FFF2-40B4-BE49-F238E27FC236}">
                    <a16:creationId xmlns:a16="http://schemas.microsoft.com/office/drawing/2014/main" id="{26A6995B-2D4D-5800-F61F-397AA3B29C52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 rot="16200000">
                <a:off x="-94786" y="3751011"/>
                <a:ext cx="113281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7 – BV605</a:t>
                </a:r>
                <a:endParaRPr lang="es-E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89 CuadroTexto">
                <a:extLst>
                  <a:ext uri="{FF2B5EF4-FFF2-40B4-BE49-F238E27FC236}">
                    <a16:creationId xmlns:a16="http://schemas.microsoft.com/office/drawing/2014/main" id="{019A7D76-AD79-D057-D8A1-D0F5BF9C1D09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639224" y="4488154"/>
                <a:ext cx="146911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9 – PE-Cy7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01" name="95 Conector recto de flecha">
              <a:extLst>
                <a:ext uri="{FF2B5EF4-FFF2-40B4-BE49-F238E27FC236}">
                  <a16:creationId xmlns:a16="http://schemas.microsoft.com/office/drawing/2014/main" id="{635B59F6-81F1-C2ED-22BD-DCFE8BBB8611}"/>
                </a:ext>
              </a:extLst>
            </p:cNvPr>
            <p:cNvCxnSpPr>
              <a:cxnSpLocks noGrp="1" noRot="1" noMove="1" noResize="1" noEditPoints="1" noAdjustHandles="1" noChangeArrowheads="1" noChangeShapeType="1"/>
            </p:cNvCxnSpPr>
            <p:nvPr/>
          </p:nvCxnSpPr>
          <p:spPr>
            <a:xfrm>
              <a:off x="6385382" y="1955328"/>
              <a:ext cx="626131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Grupo 12">
              <a:extLst>
                <a:ext uri="{FF2B5EF4-FFF2-40B4-BE49-F238E27FC236}">
                  <a16:creationId xmlns:a16="http://schemas.microsoft.com/office/drawing/2014/main" id="{68DC0B41-72BA-F38E-95EC-B0F8F1D876AE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7091480" y="314697"/>
              <a:ext cx="1913045" cy="1427364"/>
              <a:chOff x="2467760" y="2641198"/>
              <a:chExt cx="1913045" cy="1427364"/>
            </a:xfrm>
          </p:grpSpPr>
          <p:grpSp>
            <p:nvGrpSpPr>
              <p:cNvPr id="11" name="Grupo 10">
                <a:extLst>
                  <a:ext uri="{FF2B5EF4-FFF2-40B4-BE49-F238E27FC236}">
                    <a16:creationId xmlns:a16="http://schemas.microsoft.com/office/drawing/2014/main" id="{2A7EDEAD-383C-8CCB-4B5E-BE5A22FE21D6}"/>
                  </a:ext>
                </a:extLst>
              </p:cNvPr>
              <p:cNvGrpSpPr>
                <a:grpSpLocks noGrp="1" noUngrp="1" noRot="1" noMove="1" noResize="1"/>
              </p:cNvGrpSpPr>
              <p:nvPr/>
            </p:nvGrpSpPr>
            <p:grpSpPr>
              <a:xfrm>
                <a:off x="2509353" y="2641198"/>
                <a:ext cx="1871452" cy="1427364"/>
                <a:chOff x="2509353" y="2641198"/>
                <a:chExt cx="1871452" cy="1427364"/>
              </a:xfrm>
            </p:grpSpPr>
            <p:pic>
              <p:nvPicPr>
                <p:cNvPr id="98" name="Imagen 97">
                  <a:extLst>
                    <a:ext uri="{FF2B5EF4-FFF2-40B4-BE49-F238E27FC236}">
                      <a16:creationId xmlns:a16="http://schemas.microsoft.com/office/drawing/2014/main" id="{C422E70C-CC73-EF90-32ED-5B6954B133FE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 noCrop="1"/>
                </p:cNvPicPr>
                <p:nvPr/>
              </p:nvPicPr>
              <p:blipFill rotWithShape="1">
                <a:blip r:embed="rId3"/>
                <a:srcRect l="53812" b="11130"/>
                <a:stretch/>
              </p:blipFill>
              <p:spPr>
                <a:xfrm>
                  <a:off x="2652852" y="2669436"/>
                  <a:ext cx="1615285" cy="1258691"/>
                </a:xfrm>
                <a:prstGeom prst="rect">
                  <a:avLst/>
                </a:prstGeom>
              </p:spPr>
            </p:pic>
            <p:sp>
              <p:nvSpPr>
                <p:cNvPr id="111" name="58 Rectángulo">
                  <a:extLst>
                    <a:ext uri="{FF2B5EF4-FFF2-40B4-BE49-F238E27FC236}">
                      <a16:creationId xmlns:a16="http://schemas.microsoft.com/office/drawing/2014/main" id="{1240422C-D431-D80C-B06C-F04F500322AC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3116877" y="2641198"/>
                  <a:ext cx="882175" cy="1509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20" name="58 Rectángulo">
                  <a:extLst>
                    <a:ext uri="{FF2B5EF4-FFF2-40B4-BE49-F238E27FC236}">
                      <a16:creationId xmlns:a16="http://schemas.microsoft.com/office/drawing/2014/main" id="{4CDB41E7-D8D7-6843-4E54-4D2CB2B97734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3401712" y="2929264"/>
                  <a:ext cx="537809" cy="55354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25" name="89 CuadroTexto">
                  <a:extLst>
                    <a:ext uri="{FF2B5EF4-FFF2-40B4-BE49-F238E27FC236}">
                      <a16:creationId xmlns:a16="http://schemas.microsoft.com/office/drawing/2014/main" id="{E83E5C2A-97BC-75D2-FEE8-B6B4E041B43D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2764436" y="3868507"/>
                  <a:ext cx="138019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YTOX – V450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88 CuadroTexto">
                  <a:extLst>
                    <a:ext uri="{FF2B5EF4-FFF2-40B4-BE49-F238E27FC236}">
                      <a16:creationId xmlns:a16="http://schemas.microsoft.com/office/drawing/2014/main" id="{310C7EEF-21C4-31C9-11A8-DDED004A852B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 rot="16200000">
                  <a:off x="2088030" y="3184035"/>
                  <a:ext cx="104270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  <a:endParaRPr lang="es-ES" sz="5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19 CuadroTexto">
                  <a:extLst>
                    <a:ext uri="{FF2B5EF4-FFF2-40B4-BE49-F238E27FC236}">
                      <a16:creationId xmlns:a16="http://schemas.microsoft.com/office/drawing/2014/main" id="{46697842-539B-2226-8FA4-FFC07379A504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3188609" y="3214507"/>
                  <a:ext cx="11921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 algn="ctr">
                    <a:defRPr sz="7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ca-ES" dirty="0"/>
                    <a:t>% CD27</a:t>
                  </a:r>
                  <a:r>
                    <a:rPr lang="en-GB" baseline="300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s-E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r>
                    <a:rPr lang="ca-ES" dirty="0" err="1"/>
                    <a:t>dead</a:t>
                  </a:r>
                  <a:r>
                    <a:rPr lang="ca-ES" dirty="0"/>
                    <a:t> B cells</a:t>
                  </a:r>
                  <a:endParaRPr lang="es-ES" dirty="0"/>
                </a:p>
              </p:txBody>
            </p:sp>
          </p:grpSp>
          <p:sp>
            <p:nvSpPr>
              <p:cNvPr id="117" name="58 Rectángulo">
                <a:extLst>
                  <a:ext uri="{FF2B5EF4-FFF2-40B4-BE49-F238E27FC236}">
                    <a16:creationId xmlns:a16="http://schemas.microsoft.com/office/drawing/2014/main" id="{A67581B4-57BC-B990-941D-E78D9E320B53}"/>
                  </a:ext>
                </a:extLst>
              </p:cNvPr>
              <p:cNvSpPr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2467760" y="3805414"/>
                <a:ext cx="263030" cy="15095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5" name="Grupo 14">
              <a:extLst>
                <a:ext uri="{FF2B5EF4-FFF2-40B4-BE49-F238E27FC236}">
                  <a16:creationId xmlns:a16="http://schemas.microsoft.com/office/drawing/2014/main" id="{25D27A03-B7B2-BCA2-57C0-7FDB3BB96F65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7102138" y="1717716"/>
              <a:ext cx="1726965" cy="1437685"/>
              <a:chOff x="2472820" y="4057771"/>
              <a:chExt cx="1726965" cy="1437685"/>
            </a:xfrm>
          </p:grpSpPr>
          <p:grpSp>
            <p:nvGrpSpPr>
              <p:cNvPr id="12" name="Grupo 11">
                <a:extLst>
                  <a:ext uri="{FF2B5EF4-FFF2-40B4-BE49-F238E27FC236}">
                    <a16:creationId xmlns:a16="http://schemas.microsoft.com/office/drawing/2014/main" id="{7F4B58C1-AA81-D206-FC13-3FCA78ED4198}"/>
                  </a:ext>
                </a:extLst>
              </p:cNvPr>
              <p:cNvGrpSpPr>
                <a:grpSpLocks noGrp="1" noUngrp="1" noRot="1" noMove="1" noResize="1"/>
              </p:cNvGrpSpPr>
              <p:nvPr/>
            </p:nvGrpSpPr>
            <p:grpSpPr>
              <a:xfrm>
                <a:off x="2518332" y="4057771"/>
                <a:ext cx="1681453" cy="1437685"/>
                <a:chOff x="2518332" y="4057771"/>
                <a:chExt cx="1681453" cy="1437685"/>
              </a:xfrm>
            </p:grpSpPr>
            <p:pic>
              <p:nvPicPr>
                <p:cNvPr id="14" name="Imagen 13">
                  <a:extLst>
                    <a:ext uri="{FF2B5EF4-FFF2-40B4-BE49-F238E27FC236}">
                      <a16:creationId xmlns:a16="http://schemas.microsoft.com/office/drawing/2014/main" id="{19D37E51-85CF-7732-11F3-4CF8E4226CFF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 noCrop="1"/>
                </p:cNvPicPr>
                <p:nvPr/>
              </p:nvPicPr>
              <p:blipFill rotWithShape="1">
                <a:blip r:embed="rId3"/>
                <a:srcRect l="4428" r="51701" b="11130"/>
                <a:stretch/>
              </p:blipFill>
              <p:spPr>
                <a:xfrm>
                  <a:off x="2665553" y="4063990"/>
                  <a:ext cx="1534232" cy="1258690"/>
                </a:xfrm>
                <a:prstGeom prst="rect">
                  <a:avLst/>
                </a:prstGeom>
              </p:spPr>
            </p:pic>
            <p:sp>
              <p:nvSpPr>
                <p:cNvPr id="119" name="58 Rectángulo">
                  <a:extLst>
                    <a:ext uri="{FF2B5EF4-FFF2-40B4-BE49-F238E27FC236}">
                      <a16:creationId xmlns:a16="http://schemas.microsoft.com/office/drawing/2014/main" id="{F5F5C001-ECCD-69DB-23EE-00073A3FBCB8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3432668" y="4259235"/>
                  <a:ext cx="506853" cy="69574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21" name="58 Rectángulo">
                  <a:extLst>
                    <a:ext uri="{FF2B5EF4-FFF2-40B4-BE49-F238E27FC236}">
                      <a16:creationId xmlns:a16="http://schemas.microsoft.com/office/drawing/2014/main" id="{9A01B13E-88FF-AE27-06A8-E6E8216B4169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3204729" y="4057771"/>
                  <a:ext cx="537809" cy="1509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27" name="89 CuadroTexto">
                  <a:extLst>
                    <a:ext uri="{FF2B5EF4-FFF2-40B4-BE49-F238E27FC236}">
                      <a16:creationId xmlns:a16="http://schemas.microsoft.com/office/drawing/2014/main" id="{C24661A3-62CC-5D30-6BCC-03A0446F699D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2798541" y="5280012"/>
                  <a:ext cx="138019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800" b="1" dirty="0"/>
                    <a:t>SYTOX – V450</a:t>
                  </a:r>
                  <a:endParaRPr lang="es-ES" sz="800" b="1" dirty="0"/>
                </a:p>
              </p:txBody>
            </p:sp>
            <p:sp>
              <p:nvSpPr>
                <p:cNvPr id="129" name="88 CuadroTexto">
                  <a:extLst>
                    <a:ext uri="{FF2B5EF4-FFF2-40B4-BE49-F238E27FC236}">
                      <a16:creationId xmlns:a16="http://schemas.microsoft.com/office/drawing/2014/main" id="{E50B2CE6-C51D-A676-7EF3-928B23D219E5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 rot="16200000">
                  <a:off x="2094530" y="4585532"/>
                  <a:ext cx="106304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800" b="1" dirty="0"/>
                    <a:t>SSC</a:t>
                  </a:r>
                  <a:endParaRPr lang="es-ES" sz="600" b="1" dirty="0"/>
                </a:p>
              </p:txBody>
            </p:sp>
            <p:sp>
              <p:nvSpPr>
                <p:cNvPr id="140" name="19 CuadroTexto">
                  <a:extLst>
                    <a:ext uri="{FF2B5EF4-FFF2-40B4-BE49-F238E27FC236}">
                      <a16:creationId xmlns:a16="http://schemas.microsoft.com/office/drawing/2014/main" id="{882A5CE6-E690-C58E-F07B-643AFB7645C9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3296459" y="4683993"/>
                  <a:ext cx="7294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 </a:t>
                  </a:r>
                  <a:r>
                    <a:rPr lang="en-GB" sz="700" b="1" dirty="0">
                      <a:effectLst/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D27</a:t>
                  </a:r>
                  <a:r>
                    <a:rPr lang="en-GB" sz="700" b="1" baseline="30000" dirty="0">
                      <a:effectLst/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- </a:t>
                  </a:r>
                  <a:r>
                    <a:rPr lang="ca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ead</a:t>
                  </a:r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B cells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8" name="58 Rectángulo">
                <a:extLst>
                  <a:ext uri="{FF2B5EF4-FFF2-40B4-BE49-F238E27FC236}">
                    <a16:creationId xmlns:a16="http://schemas.microsoft.com/office/drawing/2014/main" id="{36E6D6CE-A39B-55E7-A00C-BF6713A19DA5}"/>
                  </a:ext>
                </a:extLst>
              </p:cNvPr>
              <p:cNvSpPr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2472820" y="5196931"/>
                <a:ext cx="263030" cy="15095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cxnSp>
          <p:nvCxnSpPr>
            <p:cNvPr id="27" name="95 Conector recto de flecha">
              <a:extLst>
                <a:ext uri="{FF2B5EF4-FFF2-40B4-BE49-F238E27FC236}">
                  <a16:creationId xmlns:a16="http://schemas.microsoft.com/office/drawing/2014/main" id="{27D367E0-6ED7-6F1B-C94D-051BE7FD8A39}"/>
                </a:ext>
              </a:extLst>
            </p:cNvPr>
            <p:cNvCxnSpPr>
              <a:cxnSpLocks noGrp="1" noRot="1" noMove="1" noResize="1" noEditPoints="1" noAdjustHandles="1" noChangeArrowheads="1" noChangeShapeType="1"/>
            </p:cNvCxnSpPr>
            <p:nvPr/>
          </p:nvCxnSpPr>
          <p:spPr>
            <a:xfrm flipV="1">
              <a:off x="6378710" y="1183042"/>
              <a:ext cx="675333" cy="328361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Grupo 30">
              <a:extLst>
                <a:ext uri="{FF2B5EF4-FFF2-40B4-BE49-F238E27FC236}">
                  <a16:creationId xmlns:a16="http://schemas.microsoft.com/office/drawing/2014/main" id="{9FCAF3E9-5F1D-CCB7-B703-DBB848581706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619875" y="1008329"/>
              <a:ext cx="4717107" cy="1532708"/>
              <a:chOff x="309105" y="959343"/>
              <a:chExt cx="4717107" cy="1532708"/>
            </a:xfrm>
          </p:grpSpPr>
          <p:grpSp>
            <p:nvGrpSpPr>
              <p:cNvPr id="25" name="Grupo 24">
                <a:extLst>
                  <a:ext uri="{FF2B5EF4-FFF2-40B4-BE49-F238E27FC236}">
                    <a16:creationId xmlns:a16="http://schemas.microsoft.com/office/drawing/2014/main" id="{8DA1B7A6-BC76-1DA1-57CF-764205F4D5B8}"/>
                  </a:ext>
                </a:extLst>
              </p:cNvPr>
              <p:cNvGrpSpPr>
                <a:grpSpLocks noGrp="1" noUngrp="1" noRot="1" noMove="1" noResize="1"/>
              </p:cNvGrpSpPr>
              <p:nvPr/>
            </p:nvGrpSpPr>
            <p:grpSpPr>
              <a:xfrm>
                <a:off x="309105" y="971203"/>
                <a:ext cx="2096273" cy="1484588"/>
                <a:chOff x="309105" y="971203"/>
                <a:chExt cx="2096273" cy="1484588"/>
              </a:xfrm>
            </p:grpSpPr>
            <p:pic>
              <p:nvPicPr>
                <p:cNvPr id="3" name="Imagen 2">
                  <a:extLst>
                    <a:ext uri="{FF2B5EF4-FFF2-40B4-BE49-F238E27FC236}">
                      <a16:creationId xmlns:a16="http://schemas.microsoft.com/office/drawing/2014/main" id="{040C0440-7432-9B1B-8721-62DA206D7BAB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 noCrop="1"/>
                </p:cNvPicPr>
                <p:nvPr/>
              </p:nvPicPr>
              <p:blipFill rotWithShape="1">
                <a:blip r:embed="rId4"/>
                <a:srcRect l="3789" t="7051" r="49563" b="9827"/>
                <a:stretch/>
              </p:blipFill>
              <p:spPr>
                <a:xfrm>
                  <a:off x="479566" y="1075902"/>
                  <a:ext cx="1925812" cy="1278018"/>
                </a:xfrm>
                <a:prstGeom prst="rect">
                  <a:avLst/>
                </a:prstGeom>
              </p:spPr>
            </p:pic>
            <p:sp>
              <p:nvSpPr>
                <p:cNvPr id="109" name="58 Rectángulo">
                  <a:extLst>
                    <a:ext uri="{FF2B5EF4-FFF2-40B4-BE49-F238E27FC236}">
                      <a16:creationId xmlns:a16="http://schemas.microsoft.com/office/drawing/2014/main" id="{6E93B888-9942-8A6E-A7DF-0C574FAC7FC9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980593" y="971203"/>
                  <a:ext cx="986941" cy="15181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10" name="58 Rectángulo">
                  <a:extLst>
                    <a:ext uri="{FF2B5EF4-FFF2-40B4-BE49-F238E27FC236}">
                      <a16:creationId xmlns:a16="http://schemas.microsoft.com/office/drawing/2014/main" id="{902BDE11-D6E8-C7FF-6EB6-142368D8776D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1716835" y="1173094"/>
                  <a:ext cx="467706" cy="11200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15" name="58 Rectángulo">
                  <a:extLst>
                    <a:ext uri="{FF2B5EF4-FFF2-40B4-BE49-F238E27FC236}">
                      <a16:creationId xmlns:a16="http://schemas.microsoft.com/office/drawing/2014/main" id="{59CB0312-B1F8-09AB-C94F-C044808C041E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334838" y="2220429"/>
                  <a:ext cx="263030" cy="1509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35" name="88 CuadroTexto">
                  <a:extLst>
                    <a:ext uri="{FF2B5EF4-FFF2-40B4-BE49-F238E27FC236}">
                      <a16:creationId xmlns:a16="http://schemas.microsoft.com/office/drawing/2014/main" id="{3A8C547E-0A7E-28E9-65FD-9DFE445A3655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 rot="16200000">
                  <a:off x="-119168" y="1530770"/>
                  <a:ext cx="105660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  <a:endParaRPr lang="es-ES" sz="5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74 CuadroTexto">
                  <a:extLst>
                    <a:ext uri="{FF2B5EF4-FFF2-40B4-BE49-F238E27FC236}">
                      <a16:creationId xmlns:a16="http://schemas.microsoft.com/office/drawing/2014/main" id="{2B7B8AB5-8297-0ACA-CD75-A89FDCB91781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613865" y="2255736"/>
                  <a:ext cx="161654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</a:t>
                  </a:r>
                  <a:endParaRPr lang="es-ES" sz="5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3" name="Grupo 22">
                <a:extLst>
                  <a:ext uri="{FF2B5EF4-FFF2-40B4-BE49-F238E27FC236}">
                    <a16:creationId xmlns:a16="http://schemas.microsoft.com/office/drawing/2014/main" id="{A5254A12-7377-C7C3-21DF-35CFF3C664CD}"/>
                  </a:ext>
                </a:extLst>
              </p:cNvPr>
              <p:cNvGrpSpPr>
                <a:grpSpLocks noGrp="1" noUngrp="1" noRot="1" noMove="1" noResize="1"/>
              </p:cNvGrpSpPr>
              <p:nvPr/>
            </p:nvGrpSpPr>
            <p:grpSpPr>
              <a:xfrm>
                <a:off x="2528874" y="959343"/>
                <a:ext cx="2006898" cy="1532708"/>
                <a:chOff x="5102225" y="4706341"/>
                <a:chExt cx="2006898" cy="1532708"/>
              </a:xfrm>
            </p:grpSpPr>
            <p:pic>
              <p:nvPicPr>
                <p:cNvPr id="2" name="Imagen 1">
                  <a:extLst>
                    <a:ext uri="{FF2B5EF4-FFF2-40B4-BE49-F238E27FC236}">
                      <a16:creationId xmlns:a16="http://schemas.microsoft.com/office/drawing/2014/main" id="{E8FE7B22-C45B-3A95-E9BB-149FE8ED1927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 noCrop="1"/>
                </p:cNvPicPr>
                <p:nvPr/>
              </p:nvPicPr>
              <p:blipFill rotWithShape="1">
                <a:blip r:embed="rId4"/>
                <a:srcRect l="56997" t="7051" b="9827"/>
                <a:stretch/>
              </p:blipFill>
              <p:spPr>
                <a:xfrm>
                  <a:off x="5333748" y="4791928"/>
                  <a:ext cx="1775375" cy="1278018"/>
                </a:xfrm>
                <a:prstGeom prst="rect">
                  <a:avLst/>
                </a:prstGeom>
              </p:spPr>
            </p:pic>
            <p:sp>
              <p:nvSpPr>
                <p:cNvPr id="112" name="58 Rectángulo">
                  <a:extLst>
                    <a:ext uri="{FF2B5EF4-FFF2-40B4-BE49-F238E27FC236}">
                      <a16:creationId xmlns:a16="http://schemas.microsoft.com/office/drawing/2014/main" id="{6B403ECE-3E8F-1B06-0EFD-1E1D0BB5C23E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5822610" y="5452227"/>
                  <a:ext cx="882175" cy="1509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6" name="58 Rectángulo">
                  <a:extLst>
                    <a:ext uri="{FF2B5EF4-FFF2-40B4-BE49-F238E27FC236}">
                      <a16:creationId xmlns:a16="http://schemas.microsoft.com/office/drawing/2014/main" id="{5A2A92D1-7FA9-09A6-5FDF-E9D523118AF6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5650422" y="4706341"/>
                  <a:ext cx="986941" cy="15181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8" name="89 CuadroTexto">
                  <a:extLst>
                    <a:ext uri="{FF2B5EF4-FFF2-40B4-BE49-F238E27FC236}">
                      <a16:creationId xmlns:a16="http://schemas.microsoft.com/office/drawing/2014/main" id="{605DDAA3-2729-381D-D3B8-0EA9E899720F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5472151" y="6038994"/>
                  <a:ext cx="140487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9 – PE-Cy7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88 CuadroTexto">
                  <a:extLst>
                    <a:ext uri="{FF2B5EF4-FFF2-40B4-BE49-F238E27FC236}">
                      <a16:creationId xmlns:a16="http://schemas.microsoft.com/office/drawing/2014/main" id="{AF320D5B-AC11-8F5A-D3C6-7F999D222F31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 rot="16200000">
                  <a:off x="4686021" y="5292463"/>
                  <a:ext cx="1163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  <a:endParaRPr lang="es-ES" sz="5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93 CuadroTexto">
                  <a:extLst>
                    <a:ext uri="{FF2B5EF4-FFF2-40B4-BE49-F238E27FC236}">
                      <a16:creationId xmlns:a16="http://schemas.microsoft.com/office/drawing/2014/main" id="{68219D21-BA59-E2DB-6BE1-5E7011D9842C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6205485" y="5452227"/>
                  <a:ext cx="50727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9</a:t>
                  </a:r>
                  <a:r>
                    <a:rPr lang="en-GB" sz="700" b="1" baseline="300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21" name="58 Rectángulo">
                  <a:extLst>
                    <a:ext uri="{FF2B5EF4-FFF2-40B4-BE49-F238E27FC236}">
                      <a16:creationId xmlns:a16="http://schemas.microsoft.com/office/drawing/2014/main" id="{B6A833B6-A323-8F99-1B4A-070E9C010CC6}"/>
                    </a:ext>
                  </a:extLst>
                </p:cNvPr>
                <p:cNvSpPr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5102225" y="5908675"/>
                  <a:ext cx="292175" cy="19155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</p:grpSp>
          <p:cxnSp>
            <p:nvCxnSpPr>
              <p:cNvPr id="133" name="96 Conector recto de flecha">
                <a:extLst>
                  <a:ext uri="{FF2B5EF4-FFF2-40B4-BE49-F238E27FC236}">
                    <a16:creationId xmlns:a16="http://schemas.microsoft.com/office/drawing/2014/main" id="{9AFC05D6-0A2F-1040-A4A7-5850B5F40598}"/>
                  </a:ext>
                </a:extLst>
              </p:cNvPr>
              <p:cNvCxnSpPr>
                <a:cxnSpLocks noGrp="1" noRot="1" noMove="1" noResize="1" noEditPoints="1" noAdjustHandles="1" noChangeArrowheads="1" noChangeShapeType="1"/>
              </p:cNvCxnSpPr>
              <p:nvPr/>
            </p:nvCxnSpPr>
            <p:spPr>
              <a:xfrm>
                <a:off x="4139410" y="2032331"/>
                <a:ext cx="88680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96 Conector recto de flecha">
                <a:extLst>
                  <a:ext uri="{FF2B5EF4-FFF2-40B4-BE49-F238E27FC236}">
                    <a16:creationId xmlns:a16="http://schemas.microsoft.com/office/drawing/2014/main" id="{6D492F0A-9E1D-6F00-BAD0-A8C8FD024628}"/>
                  </a:ext>
                </a:extLst>
              </p:cNvPr>
              <p:cNvCxnSpPr>
                <a:cxnSpLocks noGrp="1" noRot="1" noMove="1" noResize="1" noEditPoints="1" noAdjustHandles="1" noChangeArrowheads="1" noChangeShapeType="1"/>
              </p:cNvCxnSpPr>
              <p:nvPr/>
            </p:nvCxnSpPr>
            <p:spPr>
              <a:xfrm>
                <a:off x="2225328" y="2032331"/>
                <a:ext cx="461453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9" name="CuadroTexto 258">
              <a:extLst>
                <a:ext uri="{FF2B5EF4-FFF2-40B4-BE49-F238E27FC236}">
                  <a16:creationId xmlns:a16="http://schemas.microsoft.com/office/drawing/2014/main" id="{630C083B-8366-91B8-AC1D-4D31BBB18374}"/>
                </a:ext>
              </a:extLst>
            </p:cNvPr>
            <p:cNvSpPr txBox="1"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320549" y="2734547"/>
              <a:ext cx="1135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grpSp>
          <p:nvGrpSpPr>
            <p:cNvPr id="254" name="Grupo 253">
              <a:extLst>
                <a:ext uri="{FF2B5EF4-FFF2-40B4-BE49-F238E27FC236}">
                  <a16:creationId xmlns:a16="http://schemas.microsoft.com/office/drawing/2014/main" id="{D7498976-8511-6FDB-D36A-4E49B95EDC5E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673710" y="3235674"/>
              <a:ext cx="2493877" cy="2815852"/>
              <a:chOff x="5486999" y="1363688"/>
              <a:chExt cx="2795726" cy="3102005"/>
            </a:xfrm>
          </p:grpSpPr>
          <p:grpSp>
            <p:nvGrpSpPr>
              <p:cNvPr id="253" name="Grupo 252">
                <a:extLst>
                  <a:ext uri="{FF2B5EF4-FFF2-40B4-BE49-F238E27FC236}">
                    <a16:creationId xmlns:a16="http://schemas.microsoft.com/office/drawing/2014/main" id="{072FE2A9-0DCA-807F-669D-1C63E94D5084}"/>
                  </a:ext>
                </a:extLst>
              </p:cNvPr>
              <p:cNvGrpSpPr>
                <a:grpSpLocks noGrp="1" noUngrp="1" noRot="1" noMove="1" noResize="1"/>
              </p:cNvGrpSpPr>
              <p:nvPr/>
            </p:nvGrpSpPr>
            <p:grpSpPr>
              <a:xfrm>
                <a:off x="5526132" y="1363688"/>
                <a:ext cx="2756593" cy="3102005"/>
                <a:chOff x="5846727" y="1251692"/>
                <a:chExt cx="2756593" cy="3102005"/>
              </a:xfrm>
            </p:grpSpPr>
            <p:grpSp>
              <p:nvGrpSpPr>
                <p:cNvPr id="163" name="Grupo 162">
                  <a:extLst>
                    <a:ext uri="{FF2B5EF4-FFF2-40B4-BE49-F238E27FC236}">
                      <a16:creationId xmlns:a16="http://schemas.microsoft.com/office/drawing/2014/main" id="{060368AB-3C00-8A8C-628C-B32F600009E6}"/>
                    </a:ext>
                  </a:extLst>
                </p:cNvPr>
                <p:cNvGrpSpPr>
                  <a:grpSpLocks noGrp="1" noUngrp="1" noRot="1" noMove="1" noResize="1"/>
                </p:cNvGrpSpPr>
                <p:nvPr/>
              </p:nvGrpSpPr>
              <p:grpSpPr>
                <a:xfrm>
                  <a:off x="5846727" y="1251692"/>
                  <a:ext cx="2756593" cy="3102005"/>
                  <a:chOff x="5846727" y="1251692"/>
                  <a:chExt cx="2756593" cy="3102005"/>
                </a:xfrm>
              </p:grpSpPr>
              <p:pic>
                <p:nvPicPr>
                  <p:cNvPr id="17" name="Imagen 16">
                    <a:extLst>
                      <a:ext uri="{FF2B5EF4-FFF2-40B4-BE49-F238E27FC236}">
                        <a16:creationId xmlns:a16="http://schemas.microsoft.com/office/drawing/2014/main" id="{D8435EF0-516C-8A46-8A73-08FF72A02F08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 noCrop="1"/>
                  </p:cNvPicPr>
                  <p:nvPr/>
                </p:nvPicPr>
                <p:blipFill rotWithShape="1">
                  <a:blip r:embed="rId5"/>
                  <a:srcRect t="7614"/>
                  <a:stretch/>
                </p:blipFill>
                <p:spPr>
                  <a:xfrm>
                    <a:off x="5846727" y="1251692"/>
                    <a:ext cx="2756593" cy="3102005"/>
                  </a:xfrm>
                  <a:prstGeom prst="rect">
                    <a:avLst/>
                  </a:prstGeom>
                </p:spPr>
              </p:pic>
              <p:sp>
                <p:nvSpPr>
                  <p:cNvPr id="162" name="Rectángulo 161">
                    <a:extLst>
                      <a:ext uri="{FF2B5EF4-FFF2-40B4-BE49-F238E27FC236}">
                        <a16:creationId xmlns:a16="http://schemas.microsoft.com/office/drawing/2014/main" id="{DEB424A8-C45F-2D57-79C4-99F7EE1B1CC0}"/>
                      </a:ext>
                    </a:extLst>
                  </p:cNvPr>
                  <p:cNvSpPr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6169696" y="3936645"/>
                    <a:ext cx="2019300" cy="331863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</p:grpSp>
            <p:sp>
              <p:nvSpPr>
                <p:cNvPr id="160" name="CuadroTexto 159">
                  <a:extLst>
                    <a:ext uri="{FF2B5EF4-FFF2-40B4-BE49-F238E27FC236}">
                      <a16:creationId xmlns:a16="http://schemas.microsoft.com/office/drawing/2014/main" id="{D2F1D7A8-DD45-555D-EBB3-8AD99C71C7C3}"/>
                    </a:ext>
                  </a:extLst>
                </p:cNvPr>
                <p:cNvSpPr txBox="1">
                  <a:spLocks noGrp="1" noRot="1" noMove="1" noResize="1" noEditPoints="1" noAdjustHandles="1" noChangeArrowheads="1" noChangeShapeType="1"/>
                </p:cNvSpPr>
                <p:nvPr/>
              </p:nvSpPr>
              <p:spPr>
                <a:xfrm>
                  <a:off x="6212680" y="3936645"/>
                  <a:ext cx="2101850" cy="2881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ca-E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 </a:t>
                  </a:r>
                  <a:r>
                    <a:rPr lang="es-E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9</a:t>
                  </a:r>
                  <a:r>
                    <a:rPr lang="en-GB" sz="1100" baseline="300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GB" sz="1100" dirty="0">
                      <a:effectLst/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D27</a:t>
                  </a:r>
                  <a:r>
                    <a:rPr lang="en-GB" sz="1100" baseline="30000" dirty="0">
                      <a:effectLst/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s-E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B </a:t>
                  </a:r>
                  <a:r>
                    <a:rPr lang="es-ES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ells</a:t>
                  </a:r>
                  <a:endParaRPr lang="es-E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3" name="19 CuadroTexto">
                <a:extLst>
                  <a:ext uri="{FF2B5EF4-FFF2-40B4-BE49-F238E27FC236}">
                    <a16:creationId xmlns:a16="http://schemas.microsoft.com/office/drawing/2014/main" id="{F0DC8177-FBED-9B27-25DD-85FD88CA309A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 rot="16200000">
                <a:off x="4343449" y="2620442"/>
                <a:ext cx="2571749" cy="2846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ca-ES" sz="105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ad</a:t>
                </a:r>
                <a:r>
                  <a:rPr lang="ca-E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ells</a:t>
                </a:r>
                <a:endParaRPr lang="es-E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6" name="Grupo 255">
              <a:extLst>
                <a:ext uri="{FF2B5EF4-FFF2-40B4-BE49-F238E27FC236}">
                  <a16:creationId xmlns:a16="http://schemas.microsoft.com/office/drawing/2014/main" id="{35CC8CE8-A17A-CE3D-64FC-7BEF33B9B70B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3119489" y="3240865"/>
              <a:ext cx="2538026" cy="2815852"/>
              <a:chOff x="8353643" y="1322290"/>
              <a:chExt cx="2845219" cy="3102005"/>
            </a:xfrm>
          </p:grpSpPr>
          <p:pic>
            <p:nvPicPr>
              <p:cNvPr id="48" name="Imagen 47">
                <a:extLst>
                  <a:ext uri="{FF2B5EF4-FFF2-40B4-BE49-F238E27FC236}">
                    <a16:creationId xmlns:a16="http://schemas.microsoft.com/office/drawing/2014/main" id="{516F12EA-984A-6C25-2CA2-0DD23BEE863E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 noCrop="1"/>
              </p:cNvPicPr>
              <p:nvPr/>
            </p:nvPicPr>
            <p:blipFill rotWithShape="1">
              <a:blip r:embed="rId6"/>
              <a:srcRect t="7899"/>
              <a:stretch/>
            </p:blipFill>
            <p:spPr>
              <a:xfrm>
                <a:off x="8390453" y="1322290"/>
                <a:ext cx="2808409" cy="3102005"/>
              </a:xfrm>
              <a:prstGeom prst="rect">
                <a:avLst/>
              </a:prstGeom>
            </p:spPr>
          </p:pic>
          <p:sp>
            <p:nvSpPr>
              <p:cNvPr id="164" name="Rectángulo 163">
                <a:extLst>
                  <a:ext uri="{FF2B5EF4-FFF2-40B4-BE49-F238E27FC236}">
                    <a16:creationId xmlns:a16="http://schemas.microsoft.com/office/drawing/2014/main" id="{C175B115-1D89-0018-5F73-768D8EDFFCCE}"/>
                  </a:ext>
                </a:extLst>
              </p:cNvPr>
              <p:cNvSpPr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8855473" y="4001987"/>
                <a:ext cx="2019300" cy="3418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61" name="CuadroTexto 160">
                <a:extLst>
                  <a:ext uri="{FF2B5EF4-FFF2-40B4-BE49-F238E27FC236}">
                    <a16:creationId xmlns:a16="http://schemas.microsoft.com/office/drawing/2014/main" id="{0A68FAEE-96C8-0D71-8F8D-059222603313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8820149" y="4005549"/>
                <a:ext cx="2095499" cy="288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s-E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r>
                  <a:rPr lang="en-GB" sz="11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n-GB" sz="11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D27</a:t>
                </a:r>
                <a:r>
                  <a:rPr lang="en-GB" sz="1100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B </a:t>
                </a:r>
                <a:r>
                  <a:rPr lang="es-E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s-E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19 CuadroTexto">
                <a:extLst>
                  <a:ext uri="{FF2B5EF4-FFF2-40B4-BE49-F238E27FC236}">
                    <a16:creationId xmlns:a16="http://schemas.microsoft.com/office/drawing/2014/main" id="{B816AE92-3D26-E188-C0F4-86D5B4FFD31D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 rot="16200000">
                <a:off x="7210093" y="2561812"/>
                <a:ext cx="2571749" cy="2846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ca-ES" sz="105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ad</a:t>
                </a:r>
                <a:r>
                  <a:rPr lang="ca-E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ells</a:t>
                </a:r>
                <a:endParaRPr lang="es-E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45FDA2BF-922D-535B-3932-8A2760AC07C5}"/>
                </a:ext>
              </a:extLst>
            </p:cNvPr>
            <p:cNvSpPr txBox="1"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5547686" y="3178826"/>
              <a:ext cx="1135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99104BD4-A166-21B6-EAF4-1734233F02E3}"/>
                </a:ext>
              </a:extLst>
            </p:cNvPr>
            <p:cNvSpPr txBox="1"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3310780" y="2996260"/>
              <a:ext cx="11355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906C8181-4321-B78B-45CE-4DA949DAE06A}"/>
                </a:ext>
              </a:extLst>
            </p:cNvPr>
            <p:cNvSpPr txBox="1"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870246" y="2996260"/>
              <a:ext cx="11355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i)</a:t>
              </a:r>
            </a:p>
          </p:txBody>
        </p:sp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43BF0251-2994-511D-FBC1-AB1C9AD0C3FC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893727" y="2642320"/>
              <a:ext cx="5942785" cy="306118"/>
              <a:chOff x="1932120" y="65096"/>
              <a:chExt cx="5942785" cy="306118"/>
            </a:xfrm>
          </p:grpSpPr>
          <p:grpSp>
            <p:nvGrpSpPr>
              <p:cNvPr id="62" name="Grupo 61">
                <a:extLst>
                  <a:ext uri="{FF2B5EF4-FFF2-40B4-BE49-F238E27FC236}">
                    <a16:creationId xmlns:a16="http://schemas.microsoft.com/office/drawing/2014/main" id="{5137C78E-1E4A-13A7-B0D1-AAB0A979ECAF}"/>
                  </a:ext>
                </a:extLst>
              </p:cNvPr>
              <p:cNvGrpSpPr>
                <a:grpSpLocks noGrp="1" noUngrp="1" noRot="1" noMove="1" noResize="1"/>
              </p:cNvGrpSpPr>
              <p:nvPr/>
            </p:nvGrpSpPr>
            <p:grpSpPr>
              <a:xfrm>
                <a:off x="1932120" y="65096"/>
                <a:ext cx="5942785" cy="306118"/>
                <a:chOff x="2737666" y="65096"/>
                <a:chExt cx="6103957" cy="306118"/>
              </a:xfrm>
            </p:grpSpPr>
            <p:grpSp>
              <p:nvGrpSpPr>
                <p:cNvPr id="64" name="Grupo 63">
                  <a:extLst>
                    <a:ext uri="{FF2B5EF4-FFF2-40B4-BE49-F238E27FC236}">
                      <a16:creationId xmlns:a16="http://schemas.microsoft.com/office/drawing/2014/main" id="{08A2FCB1-78A8-1C48-D6CB-A16A8F6194F2}"/>
                    </a:ext>
                  </a:extLst>
                </p:cNvPr>
                <p:cNvGrpSpPr>
                  <a:grpSpLocks noGrp="1" noUngrp="1" noRot="1" noMove="1" noResize="1"/>
                </p:cNvGrpSpPr>
                <p:nvPr/>
              </p:nvGrpSpPr>
              <p:grpSpPr>
                <a:xfrm>
                  <a:off x="5617499" y="80974"/>
                  <a:ext cx="1829048" cy="290240"/>
                  <a:chOff x="9137982" y="3665987"/>
                  <a:chExt cx="1829048" cy="290240"/>
                </a:xfrm>
              </p:grpSpPr>
              <p:pic>
                <p:nvPicPr>
                  <p:cNvPr id="74" name="Imagen 73">
                    <a:extLst>
                      <a:ext uri="{FF2B5EF4-FFF2-40B4-BE49-F238E27FC236}">
                        <a16:creationId xmlns:a16="http://schemas.microsoft.com/office/drawing/2014/main" id="{ACDFACE9-7806-18B7-2016-30EDFCF699E6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 noCrop="1"/>
                  </p:cNvPicPr>
                  <p:nvPr/>
                </p:nvPicPr>
                <p:blipFill rotWithShape="1">
                  <a:blip r:embed="rId7"/>
                  <a:srcRect l="74787" t="17379" r="18960" b="77263"/>
                  <a:stretch/>
                </p:blipFill>
                <p:spPr>
                  <a:xfrm>
                    <a:off x="9137982" y="3710006"/>
                    <a:ext cx="336216" cy="246221"/>
                  </a:xfrm>
                  <a:prstGeom prst="rect">
                    <a:avLst/>
                  </a:prstGeom>
                </p:spPr>
              </p:pic>
              <p:sp>
                <p:nvSpPr>
                  <p:cNvPr id="75" name="CuadroTexto 74">
                    <a:extLst>
                      <a:ext uri="{FF2B5EF4-FFF2-40B4-BE49-F238E27FC236}">
                        <a16:creationId xmlns:a16="http://schemas.microsoft.com/office/drawing/2014/main" id="{F392C82D-33AF-1BE2-9BA8-CF67B6DEBEB1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9474195" y="3665987"/>
                    <a:ext cx="149283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C </a:t>
                    </a:r>
                    <a:r>
                      <a: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CD27</a:t>
                    </a:r>
                    <a:r>
                      <a:rPr lang="en-GB" sz="1000" baseline="300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B </a:t>
                    </a:r>
                    <a:r>
                      <a:rPr lang="es-E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es-E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5" name="Grupo 64">
                  <a:extLst>
                    <a:ext uri="{FF2B5EF4-FFF2-40B4-BE49-F238E27FC236}">
                      <a16:creationId xmlns:a16="http://schemas.microsoft.com/office/drawing/2014/main" id="{8D07D3A7-9689-F281-12DC-93F4DD96D896}"/>
                    </a:ext>
                  </a:extLst>
                </p:cNvPr>
                <p:cNvGrpSpPr>
                  <a:grpSpLocks noGrp="1" noUngrp="1" noRot="1" noMove="1" noResize="1"/>
                </p:cNvGrpSpPr>
                <p:nvPr/>
              </p:nvGrpSpPr>
              <p:grpSpPr>
                <a:xfrm>
                  <a:off x="7178031" y="71448"/>
                  <a:ext cx="1663592" cy="254900"/>
                  <a:chOff x="9303438" y="3885238"/>
                  <a:chExt cx="1663592" cy="254900"/>
                </a:xfrm>
              </p:grpSpPr>
              <p:sp>
                <p:nvSpPr>
                  <p:cNvPr id="72" name="CuadroTexto 71">
                    <a:extLst>
                      <a:ext uri="{FF2B5EF4-FFF2-40B4-BE49-F238E27FC236}">
                        <a16:creationId xmlns:a16="http://schemas.microsoft.com/office/drawing/2014/main" id="{5BA459B4-AE8C-061A-A761-388BA742FB57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9474195" y="3893917"/>
                    <a:ext cx="149283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VID </a:t>
                    </a:r>
                    <a:r>
                      <a: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CD27</a:t>
                    </a:r>
                    <a:r>
                      <a:rPr lang="en-GB" sz="1000" baseline="300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B </a:t>
                    </a:r>
                    <a:r>
                      <a:rPr lang="es-E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es-E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73" name="Imagen 72">
                    <a:extLst>
                      <a:ext uri="{FF2B5EF4-FFF2-40B4-BE49-F238E27FC236}">
                        <a16:creationId xmlns:a16="http://schemas.microsoft.com/office/drawing/2014/main" id="{54FB6DE0-4AA2-CEA1-FB9A-E6432251C943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 noCrop="1"/>
                  </p:cNvPicPr>
                  <p:nvPr/>
                </p:nvPicPr>
                <p:blipFill rotWithShape="1">
                  <a:blip r:embed="rId7"/>
                  <a:srcRect l="77864" t="21537" r="18960" b="73105"/>
                  <a:stretch/>
                </p:blipFill>
                <p:spPr>
                  <a:xfrm>
                    <a:off x="9303438" y="3885238"/>
                    <a:ext cx="170758" cy="246222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6" name="Grupo 65">
                  <a:extLst>
                    <a:ext uri="{FF2B5EF4-FFF2-40B4-BE49-F238E27FC236}">
                      <a16:creationId xmlns:a16="http://schemas.microsoft.com/office/drawing/2014/main" id="{3FD794B1-6F14-E595-52DE-D341D4777F06}"/>
                    </a:ext>
                  </a:extLst>
                </p:cNvPr>
                <p:cNvGrpSpPr>
                  <a:grpSpLocks noGrp="1" noUngrp="1" noRot="1" noMove="1" noResize="1"/>
                </p:cNvGrpSpPr>
                <p:nvPr/>
              </p:nvGrpSpPr>
              <p:grpSpPr>
                <a:xfrm>
                  <a:off x="2737666" y="68272"/>
                  <a:ext cx="1824336" cy="265273"/>
                  <a:chOff x="10005169" y="4260578"/>
                  <a:chExt cx="1824336" cy="265273"/>
                </a:xfrm>
              </p:grpSpPr>
              <p:pic>
                <p:nvPicPr>
                  <p:cNvPr id="70" name="Imagen 69">
                    <a:extLst>
                      <a:ext uri="{FF2B5EF4-FFF2-40B4-BE49-F238E27FC236}">
                        <a16:creationId xmlns:a16="http://schemas.microsoft.com/office/drawing/2014/main" id="{3BFDD7F2-1ABB-1E5B-DACD-19214F41847D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 noCrop="1"/>
                  </p:cNvPicPr>
                  <p:nvPr/>
                </p:nvPicPr>
                <p:blipFill rotWithShape="1">
                  <a:blip r:embed="rId7"/>
                  <a:srcRect l="74787" t="5568" r="18886" b="89075"/>
                  <a:stretch/>
                </p:blipFill>
                <p:spPr>
                  <a:xfrm>
                    <a:off x="10005169" y="4260578"/>
                    <a:ext cx="340209" cy="246221"/>
                  </a:xfrm>
                  <a:prstGeom prst="rect">
                    <a:avLst/>
                  </a:prstGeom>
                </p:spPr>
              </p:pic>
              <p:sp>
                <p:nvSpPr>
                  <p:cNvPr id="71" name="CuadroTexto 70">
                    <a:extLst>
                      <a:ext uri="{FF2B5EF4-FFF2-40B4-BE49-F238E27FC236}">
                        <a16:creationId xmlns:a16="http://schemas.microsoft.com/office/drawing/2014/main" id="{E73BA97D-A4F4-AFCE-5157-BCEFED47EDEC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10341866" y="4279630"/>
                    <a:ext cx="148763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C </a:t>
                    </a:r>
                    <a:r>
                      <a: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CD27</a:t>
                    </a:r>
                    <a:r>
                      <a:rPr lang="en-GB" sz="1000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-</a:t>
                    </a:r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B </a:t>
                    </a:r>
                    <a:r>
                      <a:rPr lang="es-E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es-E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7" name="Grupo 66">
                  <a:extLst>
                    <a:ext uri="{FF2B5EF4-FFF2-40B4-BE49-F238E27FC236}">
                      <a16:creationId xmlns:a16="http://schemas.microsoft.com/office/drawing/2014/main" id="{2FB6F61E-D969-5F83-314D-02ECAEF64D90}"/>
                    </a:ext>
                  </a:extLst>
                </p:cNvPr>
                <p:cNvGrpSpPr>
                  <a:grpSpLocks noGrp="1" noUngrp="1" noRot="1" noMove="1" noResize="1"/>
                </p:cNvGrpSpPr>
                <p:nvPr/>
              </p:nvGrpSpPr>
              <p:grpSpPr>
                <a:xfrm>
                  <a:off x="4133506" y="65096"/>
                  <a:ext cx="1768282" cy="262097"/>
                  <a:chOff x="10061188" y="4492158"/>
                  <a:chExt cx="1768282" cy="262097"/>
                </a:xfrm>
              </p:grpSpPr>
              <p:sp>
                <p:nvSpPr>
                  <p:cNvPr id="68" name="CuadroTexto 67">
                    <a:extLst>
                      <a:ext uri="{FF2B5EF4-FFF2-40B4-BE49-F238E27FC236}">
                        <a16:creationId xmlns:a16="http://schemas.microsoft.com/office/drawing/2014/main" id="{14D8015A-DD69-73D6-B3BF-F99E5948D5A4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10341831" y="4508034"/>
                    <a:ext cx="148763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VID </a:t>
                    </a:r>
                    <a:r>
                      <a: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CD27</a:t>
                    </a:r>
                    <a:r>
                      <a:rPr lang="en-GB" sz="1000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-</a:t>
                    </a:r>
                    <a:r>
                      <a:rPr lang="es-E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B </a:t>
                    </a:r>
                    <a:r>
                      <a:rPr lang="es-E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es-E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69" name="Imagen 68">
                    <a:extLst>
                      <a:ext uri="{FF2B5EF4-FFF2-40B4-BE49-F238E27FC236}">
                        <a16:creationId xmlns:a16="http://schemas.microsoft.com/office/drawing/2014/main" id="{F40C0B7D-97F6-C268-C407-08BEDBEDF2F8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 noCrop="1"/>
                  </p:cNvPicPr>
                  <p:nvPr/>
                </p:nvPicPr>
                <p:blipFill rotWithShape="1">
                  <a:blip r:embed="rId7"/>
                  <a:srcRect l="75803" t="10783" r="18047" b="83860"/>
                  <a:stretch/>
                </p:blipFill>
                <p:spPr>
                  <a:xfrm>
                    <a:off x="10061188" y="4492158"/>
                    <a:ext cx="330657" cy="246221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63" name="Rectángulo 62">
                <a:extLst>
                  <a:ext uri="{FF2B5EF4-FFF2-40B4-BE49-F238E27FC236}">
                    <a16:creationId xmlns:a16="http://schemas.microsoft.com/office/drawing/2014/main" id="{B3D0C36A-75B2-7161-F33D-9D4AC5D458C2}"/>
                  </a:ext>
                </a:extLst>
              </p:cNvPr>
              <p:cNvSpPr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1994397" y="65559"/>
                <a:ext cx="5777210" cy="287090"/>
              </a:xfrm>
              <a:prstGeom prst="rect">
                <a:avLst/>
              </a:prstGeom>
              <a:noFill/>
              <a:ln w="952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801"/>
              </a:p>
            </p:txBody>
          </p:sp>
        </p:grpSp>
        <p:pic>
          <p:nvPicPr>
            <p:cNvPr id="77" name="Picture 2">
              <a:extLst>
                <a:ext uri="{FF2B5EF4-FFF2-40B4-BE49-F238E27FC236}">
                  <a16:creationId xmlns:a16="http://schemas.microsoft.com/office/drawing/2014/main" id="{90CFECCB-852F-08F3-FA9E-115AA20CFE0C}"/>
                </a:ext>
              </a:extLst>
            </p:cNvPr>
            <p:cNvPicPr>
              <a:picLocks noGrp="1" noRot="1" noChangeAspect="1" noMove="1" noResize="1" noEditPoints="1" noAdjustHandles="1" noChangeArrowheads="1" noChangeShapeType="1" noCrop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94" t="13891" r="2429" b="10140"/>
            <a:stretch/>
          </p:blipFill>
          <p:spPr bwMode="auto">
            <a:xfrm>
              <a:off x="5768372" y="3862014"/>
              <a:ext cx="2854400" cy="18431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2" name="Grupo 31">
              <a:extLst>
                <a:ext uri="{FF2B5EF4-FFF2-40B4-BE49-F238E27FC236}">
                  <a16:creationId xmlns:a16="http://schemas.microsoft.com/office/drawing/2014/main" id="{DF7FED15-CB5A-0F35-9074-2D34E963936E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5557932" y="3877088"/>
              <a:ext cx="2874848" cy="2071115"/>
              <a:chOff x="5470229" y="3878064"/>
              <a:chExt cx="2874848" cy="2071115"/>
            </a:xfrm>
          </p:grpSpPr>
          <p:sp>
            <p:nvSpPr>
              <p:cNvPr id="24" name="19 CuadroTexto">
                <a:extLst>
                  <a:ext uri="{FF2B5EF4-FFF2-40B4-BE49-F238E27FC236}">
                    <a16:creationId xmlns:a16="http://schemas.microsoft.com/office/drawing/2014/main" id="{F6FA25CC-3EBD-B44E-2099-33CB02FEA150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5950220" y="5702958"/>
                <a:ext cx="239485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r>
                  <a:rPr lang="en-GB" sz="1000" b="1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 </a:t>
                </a:r>
                <a:r>
                  <a:rPr lang="en-GB" sz="1000" b="1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D27</a:t>
                </a:r>
                <a:r>
                  <a:rPr lang="en-GB" sz="1000" b="1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ca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ad</a:t>
                </a:r>
                <a:r>
                  <a:rPr lang="ca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ells</a:t>
                </a:r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id="{1CEC0D99-99B3-38C1-EF40-CE936AE1C6A0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 rot="16200000">
                <a:off x="4777250" y="4571043"/>
                <a:ext cx="1632305" cy="2463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ROX</a:t>
                </a:r>
                <a:r>
                  <a:rPr lang="en-GB" sz="1000" b="1" baseline="30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7" name="Grupo 56">
              <a:extLst>
                <a:ext uri="{FF2B5EF4-FFF2-40B4-BE49-F238E27FC236}">
                  <a16:creationId xmlns:a16="http://schemas.microsoft.com/office/drawing/2014/main" id="{4A3C0209-6CF8-1E16-979C-E22D6B3C44F1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7325622" y="3550938"/>
              <a:ext cx="1154147" cy="519674"/>
              <a:chOff x="7462275" y="3685483"/>
              <a:chExt cx="1154147" cy="519674"/>
            </a:xfrm>
          </p:grpSpPr>
          <p:sp>
            <p:nvSpPr>
              <p:cNvPr id="33" name="Rectángulo 32">
                <a:extLst>
                  <a:ext uri="{FF2B5EF4-FFF2-40B4-BE49-F238E27FC236}">
                    <a16:creationId xmlns:a16="http://schemas.microsoft.com/office/drawing/2014/main" id="{1964C671-265F-D2EB-4FC6-FDA4450B196F}"/>
                  </a:ext>
                </a:extLst>
              </p:cNvPr>
              <p:cNvSpPr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7462275" y="3685483"/>
                <a:ext cx="945740" cy="51967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34" name="CuadroTexto 33">
                <a:extLst>
                  <a:ext uri="{FF2B5EF4-FFF2-40B4-BE49-F238E27FC236}">
                    <a16:creationId xmlns:a16="http://schemas.microsoft.com/office/drawing/2014/main" id="{61BF9DAB-138B-5FD0-72B5-8CE8C84E2479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7492551" y="3689457"/>
                <a:ext cx="11238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/>
                  <a:t>r = -0.123</a:t>
                </a:r>
              </a:p>
            </p:txBody>
          </p:sp>
          <p:sp>
            <p:nvSpPr>
              <p:cNvPr id="56" name="CuadroTexto 55">
                <a:extLst>
                  <a:ext uri="{FF2B5EF4-FFF2-40B4-BE49-F238E27FC236}">
                    <a16:creationId xmlns:a16="http://schemas.microsoft.com/office/drawing/2014/main" id="{0F7A2635-D49D-066F-8993-35FC0BE6160D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7492551" y="3915415"/>
                <a:ext cx="1011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/>
                  <a:t>p = 0.56</a:t>
                </a:r>
              </a:p>
            </p:txBody>
          </p:sp>
        </p:grp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80BFD2E0-41B9-8A5A-D9D9-5A8194326A08}"/>
                </a:ext>
              </a:extLst>
            </p:cNvPr>
            <p:cNvSpPr txBox="1">
              <a:spLocks noGrp="1" noRot="1" noMove="1" noResize="1" noEditPoints="1" noAdjustHandles="1" noChangeArrowheads="1" noChangeShapeType="1"/>
            </p:cNvSpPr>
            <p:nvPr/>
          </p:nvSpPr>
          <p:spPr>
            <a:xfrm>
              <a:off x="5848242" y="3565301"/>
              <a:ext cx="11355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i)</a:t>
              </a:r>
            </a:p>
          </p:txBody>
        </p:sp>
        <p:grpSp>
          <p:nvGrpSpPr>
            <p:cNvPr id="89" name="Grupo 88">
              <a:extLst>
                <a:ext uri="{FF2B5EF4-FFF2-40B4-BE49-F238E27FC236}">
                  <a16:creationId xmlns:a16="http://schemas.microsoft.com/office/drawing/2014/main" id="{B5C3F1A3-0A1D-2563-8B8D-F16F22BB19E9}"/>
                </a:ext>
              </a:extLst>
            </p:cNvPr>
            <p:cNvGrpSpPr>
              <a:grpSpLocks noGrp="1" noUngrp="1" noRot="1" noMove="1" noResize="1"/>
            </p:cNvGrpSpPr>
            <p:nvPr/>
          </p:nvGrpSpPr>
          <p:grpSpPr>
            <a:xfrm>
              <a:off x="8495713" y="3548261"/>
              <a:ext cx="3195680" cy="2411700"/>
              <a:chOff x="8571919" y="3548261"/>
              <a:chExt cx="3195680" cy="2411700"/>
            </a:xfrm>
          </p:grpSpPr>
          <p:grpSp>
            <p:nvGrpSpPr>
              <p:cNvPr id="22" name="Grupo 21">
                <a:extLst>
                  <a:ext uri="{FF2B5EF4-FFF2-40B4-BE49-F238E27FC236}">
                    <a16:creationId xmlns:a16="http://schemas.microsoft.com/office/drawing/2014/main" id="{EF580D04-A1FC-017E-77B9-75B96015FA18}"/>
                  </a:ext>
                </a:extLst>
              </p:cNvPr>
              <p:cNvGrpSpPr>
                <a:grpSpLocks noGrp="1" noUngrp="1" noRot="1" noMove="1" noResize="1"/>
              </p:cNvGrpSpPr>
              <p:nvPr/>
            </p:nvGrpSpPr>
            <p:grpSpPr>
              <a:xfrm>
                <a:off x="8571919" y="3548261"/>
                <a:ext cx="2996377" cy="2411700"/>
                <a:chOff x="8898052" y="3562495"/>
                <a:chExt cx="2996377" cy="2411700"/>
              </a:xfrm>
            </p:grpSpPr>
            <p:grpSp>
              <p:nvGrpSpPr>
                <p:cNvPr id="10" name="Grupo 9">
                  <a:extLst>
                    <a:ext uri="{FF2B5EF4-FFF2-40B4-BE49-F238E27FC236}">
                      <a16:creationId xmlns:a16="http://schemas.microsoft.com/office/drawing/2014/main" id="{A83B4814-D00B-0A62-1A24-A82495F5918F}"/>
                    </a:ext>
                  </a:extLst>
                </p:cNvPr>
                <p:cNvGrpSpPr>
                  <a:grpSpLocks noGrp="1" noUngrp="1" noRot="1" noMove="1" noResize="1"/>
                </p:cNvGrpSpPr>
                <p:nvPr/>
              </p:nvGrpSpPr>
              <p:grpSpPr>
                <a:xfrm>
                  <a:off x="10718374" y="3562495"/>
                  <a:ext cx="1176055" cy="522300"/>
                  <a:chOff x="7828058" y="3373656"/>
                  <a:chExt cx="1176055" cy="522300"/>
                </a:xfrm>
              </p:grpSpPr>
              <p:sp>
                <p:nvSpPr>
                  <p:cNvPr id="53" name="CuadroTexto 52">
                    <a:extLst>
                      <a:ext uri="{FF2B5EF4-FFF2-40B4-BE49-F238E27FC236}">
                        <a16:creationId xmlns:a16="http://schemas.microsoft.com/office/drawing/2014/main" id="{ECE6E581-1C90-54C2-5756-0E1AD3FA614B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7880242" y="3373656"/>
                    <a:ext cx="112387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200" dirty="0"/>
                      <a:t>r = - 0.697</a:t>
                    </a:r>
                  </a:p>
                </p:txBody>
              </p:sp>
              <p:sp>
                <p:nvSpPr>
                  <p:cNvPr id="54" name="CuadroTexto 53">
                    <a:extLst>
                      <a:ext uri="{FF2B5EF4-FFF2-40B4-BE49-F238E27FC236}">
                        <a16:creationId xmlns:a16="http://schemas.microsoft.com/office/drawing/2014/main" id="{81BD2712-06E3-B105-8BED-57280B10935F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7880242" y="3599614"/>
                    <a:ext cx="101161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200" dirty="0"/>
                      <a:t>p &lt; 0.001</a:t>
                    </a:r>
                  </a:p>
                </p:txBody>
              </p:sp>
              <p:sp>
                <p:nvSpPr>
                  <p:cNvPr id="55" name="Rectángulo 54">
                    <a:extLst>
                      <a:ext uri="{FF2B5EF4-FFF2-40B4-BE49-F238E27FC236}">
                        <a16:creationId xmlns:a16="http://schemas.microsoft.com/office/drawing/2014/main" id="{660604AF-2D0E-76B2-7850-DC74F58949D1}"/>
                      </a:ext>
                    </a:extLst>
                  </p:cNvPr>
                  <p:cNvSpPr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7828058" y="3376282"/>
                    <a:ext cx="945740" cy="519674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</p:grpSp>
            <p:grpSp>
              <p:nvGrpSpPr>
                <p:cNvPr id="9" name="Grupo 8">
                  <a:extLst>
                    <a:ext uri="{FF2B5EF4-FFF2-40B4-BE49-F238E27FC236}">
                      <a16:creationId xmlns:a16="http://schemas.microsoft.com/office/drawing/2014/main" id="{2CF6E48B-C39B-D171-89ED-D0FF401C5B1A}"/>
                    </a:ext>
                  </a:extLst>
                </p:cNvPr>
                <p:cNvGrpSpPr>
                  <a:grpSpLocks noGrp="1" noUngrp="1" noRot="1" noMove="1" noResize="1"/>
                </p:cNvGrpSpPr>
                <p:nvPr/>
              </p:nvGrpSpPr>
              <p:grpSpPr>
                <a:xfrm>
                  <a:off x="8898052" y="3903081"/>
                  <a:ext cx="2874848" cy="2071114"/>
                  <a:chOff x="8898052" y="3903081"/>
                  <a:chExt cx="2874848" cy="2071114"/>
                </a:xfrm>
              </p:grpSpPr>
              <p:sp>
                <p:nvSpPr>
                  <p:cNvPr id="5" name="19 CuadroTexto">
                    <a:extLst>
                      <a:ext uri="{FF2B5EF4-FFF2-40B4-BE49-F238E27FC236}">
                        <a16:creationId xmlns:a16="http://schemas.microsoft.com/office/drawing/2014/main" id="{DE5D13FC-B20E-9A8D-B2EB-D7FA62CA1CA8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>
                    <a:off x="9378043" y="5727974"/>
                    <a:ext cx="239485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ca-E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 </a:t>
                    </a:r>
                    <a:r>
                      <a:rPr lang="es-E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9</a:t>
                    </a:r>
                    <a:r>
                      <a:rPr lang="en-GB" sz="1000" b="1" baseline="300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+ </a:t>
                    </a:r>
                    <a:r>
                      <a: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CD27</a:t>
                    </a:r>
                    <a:r>
                      <a:rPr lang="en-GB" sz="1000" b="1" baseline="300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es-E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ca-E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ad</a:t>
                    </a:r>
                    <a:r>
                      <a:rPr lang="ca-E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ells</a:t>
                    </a:r>
                    <a:endPara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" name="CuadroTexto 7">
                    <a:extLst>
                      <a:ext uri="{FF2B5EF4-FFF2-40B4-BE49-F238E27FC236}">
                        <a16:creationId xmlns:a16="http://schemas.microsoft.com/office/drawing/2014/main" id="{E789E683-FD5E-3A6D-C4F5-A116F5F0BBFA}"/>
                      </a:ext>
                    </a:extLst>
                  </p:cNvPr>
                  <p:cNvSpPr txBox="1">
                    <a:spLocks noGrp="1" noRot="1" noMove="1" noResize="1" noEditPoints="1" noAdjustHandles="1" noChangeArrowheads="1" noChangeShapeType="1"/>
                  </p:cNvSpPr>
                  <p:nvPr/>
                </p:nvSpPr>
                <p:spPr>
                  <a:xfrm rot="16200000">
                    <a:off x="8205073" y="4596060"/>
                    <a:ext cx="1632305" cy="24634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s-E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 </a:t>
                    </a:r>
                    <a:r>
                      <a:rPr lang="es-E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ROX</a:t>
                    </a:r>
                    <a:r>
                      <a:rPr lang="en-GB" sz="1000" b="1" baseline="300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es-E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s-E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es-E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58" name="CuadroTexto 57">
                <a:extLst>
                  <a:ext uri="{FF2B5EF4-FFF2-40B4-BE49-F238E27FC236}">
                    <a16:creationId xmlns:a16="http://schemas.microsoft.com/office/drawing/2014/main" id="{B5105F4E-0EA3-5943-4B7B-0D51FB0BA08D}"/>
                  </a:ext>
                </a:extLst>
              </p:cNvPr>
              <p:cNvSpPr txBox="1">
                <a:spLocks noGrp="1" noRot="1" noMove="1" noResize="1" noEditPoints="1" noAdjustHandles="1" noChangeArrowheads="1" noChangeShapeType="1"/>
              </p:cNvSpPr>
              <p:nvPr/>
            </p:nvSpPr>
            <p:spPr>
              <a:xfrm>
                <a:off x="8880384" y="3565301"/>
                <a:ext cx="113553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s-E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  <a:r>
                  <a:rPr lang="es-E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76" name="Picture 2">
                <a:extLst>
                  <a:ext uri="{FF2B5EF4-FFF2-40B4-BE49-F238E27FC236}">
                    <a16:creationId xmlns:a16="http://schemas.microsoft.com/office/drawing/2014/main" id="{769770DF-6A07-B980-9AE9-ECD67119564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 noCrop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99" t="12158" b="10648"/>
              <a:stretch/>
            </p:blipFill>
            <p:spPr bwMode="auto">
              <a:xfrm>
                <a:off x="8780325" y="3811511"/>
                <a:ext cx="2987274" cy="188152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</p:spTree>
    <p:extLst>
      <p:ext uri="{BB962C8B-B14F-4D97-AF65-F5344CB8AC3E}">
        <p14:creationId xmlns:p14="http://schemas.microsoft.com/office/powerpoint/2010/main" val="3203436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F893A722-C841-D9C6-7677-F4257B722E94}"/>
              </a:ext>
            </a:extLst>
          </p:cNvPr>
          <p:cNvSpPr txBox="1"/>
          <p:nvPr/>
        </p:nvSpPr>
        <p:spPr>
          <a:xfrm>
            <a:off x="341194" y="306284"/>
            <a:ext cx="11442593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i="0" dirty="0">
                <a:effectLst/>
                <a:latin typeface="Calibri" panose="020F0502020204030204" pitchFamily="34" charset="0"/>
              </a:rPr>
              <a:t>Figure S1.</a:t>
            </a:r>
            <a:r>
              <a:rPr lang="en-US" sz="1800" b="1" i="1" dirty="0">
                <a:effectLst/>
                <a:latin typeface="Calibri" panose="020F0502020204030204" pitchFamily="34" charset="0"/>
              </a:rPr>
              <a:t> </a:t>
            </a:r>
            <a:r>
              <a:rPr lang="en-US" sz="1800" b="1" i="0" dirty="0">
                <a:effectLst/>
                <a:latin typeface="Calibri" panose="020F0502020204030204" pitchFamily="34" charset="0"/>
              </a:rPr>
              <a:t>In vitro cell death of B cell subpopulations in healthy controls and CVID patients. (A) 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ot plots representing in vitro cell death in B cell subpopulations from a representative healthy control. Gating strategy: B cells were selected 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based on forward and side scatter and CD19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 expression. B cell subpopulations were identified as naïve CD19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CD27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-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(green color) and memory CD19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CD27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 (purple color). Dead B cells were identified by the expression of SYTOX marker. </a:t>
            </a:r>
            <a:r>
              <a:rPr lang="en-US" sz="1800" b="1" i="0" dirty="0">
                <a:effectLst/>
                <a:latin typeface="Calibri" panose="020F0502020204030204" pitchFamily="34" charset="0"/>
              </a:rPr>
              <a:t>(B) 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Percentages of dead (</a:t>
            </a:r>
            <a:r>
              <a:rPr lang="en-US" sz="1800" b="0" i="0" dirty="0" err="1">
                <a:effectLst/>
                <a:latin typeface="Calibri" panose="020F0502020204030204" pitchFamily="34" charset="0"/>
              </a:rPr>
              <a:t>i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) naïve CD19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CD27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-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 and (ii) memory CD19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CD27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 B cells from healthy controls and CVID patients. </a:t>
            </a:r>
            <a:r>
              <a:rPr lang="en-US" sz="1800" b="1" i="0" dirty="0">
                <a:effectLst/>
                <a:latin typeface="Calibri" panose="020F0502020204030204" pitchFamily="34" charset="0"/>
              </a:rPr>
              <a:t>(C) 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Correlation between in vitro cell death (% SYTOX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 cells) and ROS production (% </a:t>
            </a:r>
            <a:r>
              <a:rPr lang="en-US" sz="1800" b="0" i="0" dirty="0" err="1">
                <a:effectLst/>
                <a:latin typeface="Calibri" panose="020F0502020204030204" pitchFamily="34" charset="0"/>
              </a:rPr>
              <a:t>CellROX</a:t>
            </a:r>
            <a:r>
              <a:rPr lang="en-US" baseline="30000" dirty="0">
                <a:latin typeface="Calibri" panose="020F0502020204030204" pitchFamily="34" charset="0"/>
              </a:rPr>
              <a:t>+ </a:t>
            </a:r>
            <a:r>
              <a:rPr lang="en-US" dirty="0"/>
              <a:t>cells) on 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(</a:t>
            </a:r>
            <a:r>
              <a:rPr lang="en-US" sz="1800" b="0" i="0" dirty="0" err="1">
                <a:effectLst/>
                <a:latin typeface="Calibri" panose="020F0502020204030204" pitchFamily="34" charset="0"/>
              </a:rPr>
              <a:t>i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) healthy and (ii) CVID memory CD19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CD27</a:t>
            </a:r>
            <a:r>
              <a:rPr lang="en-US" sz="1800" b="0" i="0" baseline="30000" dirty="0">
                <a:effectLst/>
                <a:latin typeface="Calibri" panose="020F0502020204030204" pitchFamily="34" charset="0"/>
              </a:rPr>
              <a:t>+</a:t>
            </a:r>
            <a:r>
              <a:rPr lang="en-US" sz="1800" b="0" i="0" dirty="0">
                <a:effectLst/>
                <a:latin typeface="Calibri" panose="020F0502020204030204" pitchFamily="34" charset="0"/>
              </a:rPr>
              <a:t> B cells (r: Pearson’s correlation coefficient).</a:t>
            </a:r>
            <a:r>
              <a:rPr lang="en-US" sz="1800" b="0" i="0" dirty="0">
                <a:effectLst/>
              </a:rPr>
              <a:t> Panels B and C: each dot represents an individual. Green dots (naïve CD19</a:t>
            </a:r>
            <a:r>
              <a:rPr lang="en-US" sz="1800" b="0" i="0" baseline="30000" dirty="0">
                <a:effectLst/>
              </a:rPr>
              <a:t>+</a:t>
            </a:r>
            <a:r>
              <a:rPr lang="en-US" sz="1800" b="0" i="0" dirty="0">
                <a:effectLst/>
              </a:rPr>
              <a:t>CD27</a:t>
            </a:r>
            <a:r>
              <a:rPr lang="en-US" sz="1800" b="0" i="0" baseline="30000" dirty="0">
                <a:effectLst/>
              </a:rPr>
              <a:t>-</a:t>
            </a:r>
            <a:r>
              <a:rPr lang="en-US" sz="1800" b="0" i="0" dirty="0">
                <a:effectLst/>
              </a:rPr>
              <a:t>) and purple color (memory CD19</a:t>
            </a:r>
            <a:r>
              <a:rPr lang="en-US" sz="1800" b="0" i="0" baseline="30000" dirty="0">
                <a:effectLst/>
              </a:rPr>
              <a:t>+</a:t>
            </a:r>
            <a:r>
              <a:rPr lang="en-US" sz="1800" b="0" i="0" dirty="0">
                <a:effectLst/>
              </a:rPr>
              <a:t>CD27</a:t>
            </a:r>
            <a:r>
              <a:rPr lang="en-US" sz="1800" b="0" i="0" baseline="30000" dirty="0">
                <a:effectLst/>
              </a:rPr>
              <a:t>+</a:t>
            </a:r>
            <a:r>
              <a:rPr lang="en-US" sz="1800" b="0" i="0" dirty="0">
                <a:effectLst/>
              </a:rPr>
              <a:t>); empty dots (healthy controls) and filled dots (CVID patients). Panel B: Mann-Whitney test </a:t>
            </a:r>
            <a:r>
              <a:rPr lang="en-US" sz="1800" b="0" i="1" dirty="0">
                <a:effectLst/>
              </a:rPr>
              <a:t>P-</a:t>
            </a:r>
            <a:r>
              <a:rPr lang="en-US" sz="1800" b="0" i="0" dirty="0">
                <a:effectLst/>
              </a:rPr>
              <a:t>value: **</a:t>
            </a:r>
            <a:r>
              <a:rPr lang="en-US" sz="1800" b="0" i="1" dirty="0">
                <a:effectLst/>
              </a:rPr>
              <a:t>P</a:t>
            </a:r>
            <a:r>
              <a:rPr lang="en-US" sz="1800" b="0" i="0" dirty="0">
                <a:effectLst/>
              </a:rPr>
              <a:t> &lt; 0.01. </a:t>
            </a:r>
          </a:p>
          <a:p>
            <a:pPr algn="just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6922135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7</TotalTime>
  <Words>348</Words>
  <Application>Microsoft Office PowerPoint</Application>
  <PresentationFormat>Panorámica</PresentationFormat>
  <Paragraphs>40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Berman Riu</dc:creator>
  <cp:lastModifiedBy>Maria Berman Riu</cp:lastModifiedBy>
  <cp:revision>16</cp:revision>
  <dcterms:created xsi:type="dcterms:W3CDTF">2023-12-28T14:58:46Z</dcterms:created>
  <dcterms:modified xsi:type="dcterms:W3CDTF">2024-03-18T18:48:08Z</dcterms:modified>
</cp:coreProperties>
</file>